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80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5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1.xml"/><Relationship Id="rId1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2.xml"/><Relationship Id="rId1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3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4.xml"/><Relationship Id="rId1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20230914-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200400" y="518160"/>
            <a:ext cx="5930265" cy="483425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2683510" y="5636895"/>
            <a:ext cx="7910195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Figure 1A. PCR amplification result of the NSP4 gene fragment from the PRRSV XH-GD strain.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20230914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362325" y="360045"/>
            <a:ext cx="5939155" cy="4842510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2082800" y="5483225"/>
            <a:ext cx="8920480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Figure 1B. Identification of the double-enzyme digestion product of the recombinant plasmid, pET-28a-NSP4.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20230924-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614420" y="712470"/>
            <a:ext cx="5661660" cy="4615815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3969385" y="5775960"/>
            <a:ext cx="11105515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Figure 2A. Identification of the recombinant NSP4 protein by SDS-PAGE.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202307220-W1-5s HIS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387090" y="771525"/>
            <a:ext cx="5792470" cy="4721860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2661285" y="5621655"/>
            <a:ext cx="9423400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Figure 2B. Identification of NSP4 recombinant protein using western blotting with an anti-His monoclonal antibody.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20231113-PRRSV-20s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26105" y="945515"/>
            <a:ext cx="5118735" cy="4173855"/>
          </a:xfrm>
          <a:prstGeom prst="rect">
            <a:avLst/>
          </a:prstGeom>
        </p:spPr>
      </p:pic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2921000" y="5263515"/>
            <a:ext cx="8107680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lstStyle/>
          <a:p>
            <a:pPr algn="l"/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Figure 2C. Identification of NSP4 recombinant protein using western blotting with positive serum.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COMMONDATA" val="eyJoZGlkIjoiMTdlZjhkNDkxYjAwOTQwNTRhMWMyYjBmMDM2YjRhOWU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7</Words>
  <Application>WPS 演示</Application>
  <PresentationFormat>宽屏</PresentationFormat>
  <Paragraphs>10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沙惠阳</dc:creator>
  <cp:lastModifiedBy>倜荒锥赵敲</cp:lastModifiedBy>
  <cp:revision>6</cp:revision>
  <dcterms:created xsi:type="dcterms:W3CDTF">2023-08-09T12:44:00Z</dcterms:created>
  <dcterms:modified xsi:type="dcterms:W3CDTF">2024-12-20T01:22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9302</vt:lpwstr>
  </property>
</Properties>
</file>